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74" autoAdjust="0"/>
    <p:restoredTop sz="94660"/>
  </p:normalViewPr>
  <p:slideViewPr>
    <p:cSldViewPr snapToGrid="0">
      <p:cViewPr varScale="1">
        <p:scale>
          <a:sx n="59" d="100"/>
          <a:sy n="59" d="100"/>
        </p:scale>
        <p:origin x="36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wais Riaz" userId="668d683d-a3c6-4bf3-bed2-80fcc8b869ce" providerId="ADAL" clId="{1D08400D-9659-435A-9E54-23085940B1E0}"/>
    <pc:docChg chg="undo custSel modSld">
      <pc:chgData name="Awais Riaz" userId="668d683d-a3c6-4bf3-bed2-80fcc8b869ce" providerId="ADAL" clId="{1D08400D-9659-435A-9E54-23085940B1E0}" dt="2025-10-15T19:16:35.572" v="9" actId="20577"/>
      <pc:docMkLst>
        <pc:docMk/>
      </pc:docMkLst>
      <pc:sldChg chg="modSp mod">
        <pc:chgData name="Awais Riaz" userId="668d683d-a3c6-4bf3-bed2-80fcc8b869ce" providerId="ADAL" clId="{1D08400D-9659-435A-9E54-23085940B1E0}" dt="2025-10-15T19:16:35.572" v="9" actId="20577"/>
        <pc:sldMkLst>
          <pc:docMk/>
          <pc:sldMk cId="2460906986" sldId="259"/>
        </pc:sldMkLst>
        <pc:spChg chg="mod">
          <ac:chgData name="Awais Riaz" userId="668d683d-a3c6-4bf3-bed2-80fcc8b869ce" providerId="ADAL" clId="{1D08400D-9659-435A-9E54-23085940B1E0}" dt="2025-10-15T19:16:35.572" v="9" actId="20577"/>
          <ac:spMkLst>
            <pc:docMk/>
            <pc:sldMk cId="2460906986" sldId="259"/>
            <ac:spMk id="3" creationId="{F0C945D3-644F-0399-CBDE-A01C3836440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24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067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568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089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211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83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686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542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992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753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953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89146C-96D7-46E7-951C-B38D9F8C4BE2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DDB105-D6E5-4224-BA97-0D919E4302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4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diagram of a plant&#10;&#10;AI-generated content may be incorrect.">
            <a:extLst>
              <a:ext uri="{FF2B5EF4-FFF2-40B4-BE49-F238E27FC236}">
                <a16:creationId xmlns:a16="http://schemas.microsoft.com/office/drawing/2014/main" id="{B821C995-4202-77DD-5582-37BF23A347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03" t="46388" r="2837"/>
          <a:stretch/>
        </p:blipFill>
        <p:spPr>
          <a:xfrm>
            <a:off x="4664495" y="464156"/>
            <a:ext cx="3943542" cy="1451099"/>
          </a:xfrm>
          <a:prstGeom prst="rect">
            <a:avLst/>
          </a:prstGeom>
        </p:spPr>
      </p:pic>
      <p:pic>
        <p:nvPicPr>
          <p:cNvPr id="7" name="Picture 6" descr="A graph of a number of numbers and a line of pink squares&#10;&#10;AI-generated content may be incorrect.">
            <a:extLst>
              <a:ext uri="{FF2B5EF4-FFF2-40B4-BE49-F238E27FC236}">
                <a16:creationId xmlns:a16="http://schemas.microsoft.com/office/drawing/2014/main" id="{AE982C0B-0071-DE9D-34EC-3A6B465323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3" t="47336" r="4729"/>
          <a:stretch/>
        </p:blipFill>
        <p:spPr>
          <a:xfrm>
            <a:off x="264238" y="371953"/>
            <a:ext cx="3835640" cy="1386447"/>
          </a:xfrm>
          <a:prstGeom prst="rect">
            <a:avLst/>
          </a:prstGeom>
        </p:spPr>
      </p:pic>
      <p:pic>
        <p:nvPicPr>
          <p:cNvPr id="4" name="Picture 3" descr="A diagram of a diagram&#10;&#10;AI-generated content may be incorrect.">
            <a:extLst>
              <a:ext uri="{FF2B5EF4-FFF2-40B4-BE49-F238E27FC236}">
                <a16:creationId xmlns:a16="http://schemas.microsoft.com/office/drawing/2014/main" id="{0982A2BF-B210-E392-ABF2-DE8A50D680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4" t="41317" r="946"/>
          <a:stretch/>
        </p:blipFill>
        <p:spPr>
          <a:xfrm>
            <a:off x="413729" y="1990869"/>
            <a:ext cx="3835641" cy="152719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E14FE89-08DD-1165-3ACF-386E71C74C3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74" t="44042" r="4939"/>
          <a:stretch/>
        </p:blipFill>
        <p:spPr>
          <a:xfrm>
            <a:off x="245182" y="3706747"/>
            <a:ext cx="4004188" cy="1609211"/>
          </a:xfrm>
          <a:prstGeom prst="rect">
            <a:avLst/>
          </a:prstGeom>
        </p:spPr>
      </p:pic>
      <p:pic>
        <p:nvPicPr>
          <p:cNvPr id="6" name="Picture 5" descr="A diagram of a number of objects&#10;&#10;AI-generated content may be incorrect.">
            <a:extLst>
              <a:ext uri="{FF2B5EF4-FFF2-40B4-BE49-F238E27FC236}">
                <a16:creationId xmlns:a16="http://schemas.microsoft.com/office/drawing/2014/main" id="{D10D01DC-C9C6-32E6-3E19-CF030A064D4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910"/>
          <a:stretch/>
        </p:blipFill>
        <p:spPr>
          <a:xfrm>
            <a:off x="4341630" y="3595006"/>
            <a:ext cx="4695766" cy="1736423"/>
          </a:xfrm>
          <a:prstGeom prst="rect">
            <a:avLst/>
          </a:prstGeom>
        </p:spPr>
      </p:pic>
      <p:pic>
        <p:nvPicPr>
          <p:cNvPr id="8" name="Picture 7" descr="A graph with numbers and a line&#10;&#10;AI-generated content may be incorrect.">
            <a:extLst>
              <a:ext uri="{FF2B5EF4-FFF2-40B4-BE49-F238E27FC236}">
                <a16:creationId xmlns:a16="http://schemas.microsoft.com/office/drawing/2014/main" id="{A5EE6059-2841-5182-A924-A313F8DC337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948"/>
          <a:stretch/>
        </p:blipFill>
        <p:spPr>
          <a:xfrm>
            <a:off x="4279579" y="1982181"/>
            <a:ext cx="4695766" cy="1561939"/>
          </a:xfrm>
          <a:prstGeom prst="rect">
            <a:avLst/>
          </a:prstGeom>
        </p:spPr>
      </p:pic>
      <p:pic>
        <p:nvPicPr>
          <p:cNvPr id="10" name="Picture 9" descr="A diagram of a graph&#10;&#10;AI-generated content may be incorrect.">
            <a:extLst>
              <a:ext uri="{FF2B5EF4-FFF2-40B4-BE49-F238E27FC236}">
                <a16:creationId xmlns:a16="http://schemas.microsoft.com/office/drawing/2014/main" id="{F08C668E-3177-C6F3-18EC-259913F5A38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67" t="32112" r="2676"/>
          <a:stretch/>
        </p:blipFill>
        <p:spPr>
          <a:xfrm>
            <a:off x="182007" y="5508644"/>
            <a:ext cx="5185492" cy="142747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EF457F3-8287-04F0-688D-235EAFDB7899}"/>
              </a:ext>
            </a:extLst>
          </p:cNvPr>
          <p:cNvSpPr txBox="1"/>
          <p:nvPr/>
        </p:nvSpPr>
        <p:spPr>
          <a:xfrm>
            <a:off x="182006" y="230192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9356EA-14F7-40C4-0C86-CA71B0121B93}"/>
              </a:ext>
            </a:extLst>
          </p:cNvPr>
          <p:cNvSpPr txBox="1"/>
          <p:nvPr/>
        </p:nvSpPr>
        <p:spPr>
          <a:xfrm>
            <a:off x="182006" y="3141967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7A4004-9236-AFC3-2FF6-8179E172C310}"/>
              </a:ext>
            </a:extLst>
          </p:cNvPr>
          <p:cNvSpPr txBox="1"/>
          <p:nvPr/>
        </p:nvSpPr>
        <p:spPr>
          <a:xfrm>
            <a:off x="4174630" y="254000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3D86F2-B712-2B52-950B-109E000332BD}"/>
              </a:ext>
            </a:extLst>
          </p:cNvPr>
          <p:cNvSpPr txBox="1"/>
          <p:nvPr/>
        </p:nvSpPr>
        <p:spPr>
          <a:xfrm>
            <a:off x="186508" y="1686547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FF654DA-4260-59B4-BA91-E1D7DC001242}"/>
              </a:ext>
            </a:extLst>
          </p:cNvPr>
          <p:cNvSpPr txBox="1"/>
          <p:nvPr/>
        </p:nvSpPr>
        <p:spPr>
          <a:xfrm>
            <a:off x="4192328" y="1629084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0FF29D-7F84-75BD-10D1-0C2F6B79B101}"/>
              </a:ext>
            </a:extLst>
          </p:cNvPr>
          <p:cNvSpPr txBox="1"/>
          <p:nvPr/>
        </p:nvSpPr>
        <p:spPr>
          <a:xfrm>
            <a:off x="4171450" y="3225532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601750B-2974-16F6-C706-F24EE76E05DD}"/>
              </a:ext>
            </a:extLst>
          </p:cNvPr>
          <p:cNvSpPr txBox="1"/>
          <p:nvPr/>
        </p:nvSpPr>
        <p:spPr>
          <a:xfrm>
            <a:off x="189484" y="5139312"/>
            <a:ext cx="3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C945D3-644F-0399-CBDE-A01C38364405}"/>
              </a:ext>
            </a:extLst>
          </p:cNvPr>
          <p:cNvSpPr txBox="1"/>
          <p:nvPr/>
        </p:nvSpPr>
        <p:spPr>
          <a:xfrm>
            <a:off x="37119" y="7260887"/>
            <a:ext cx="9106881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0 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plotype analysis of potential candidate genes in five selected rice accessions studied for detailed analysis of chlorophyll inflorescence, light response, and intercellular CO₂ curves. Haplotype analysis revealed that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1g0446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2g400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9g153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hibited the highest haplotype diversity among the studied accessions. Additionally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2g400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9g153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11g364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ed 2 , 2, and 4 isoforms of genes, respectively, in the rice genome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1g0375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SNPs are predominantly located in the exonic regions, with low variation among accession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1g0446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High SNP density observed across all accessions, with SNPs distributed in the promoter, exonic, intronic, and 3' UTR region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2g400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high SNP density observed in the promoter and intronic regions of gene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4g5876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showed low SNP variation, with most SNPs located in the promoter and 3' UTR regions of gene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6g4597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A single-exon gene with SNP variation observed in the promoter and exonic regions of gene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9g153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showed high SNPs density, mainly in the promoter region, with fewer SNPs scattered in the exonic, intronic, and 3' UTR regions of gene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11g3643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SNP variation is primarily observed in the first and second exons, with fewer variants scattered across the intronic and 3' UTR regions.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B11FB26D-EF82-276C-BE5C-4713B31F6F0E}"/>
              </a:ext>
            </a:extLst>
          </p:cNvPr>
          <p:cNvGrpSpPr/>
          <p:nvPr/>
        </p:nvGrpSpPr>
        <p:grpSpPr>
          <a:xfrm>
            <a:off x="5326861" y="5780987"/>
            <a:ext cx="3892130" cy="738961"/>
            <a:chOff x="5367501" y="5892159"/>
            <a:chExt cx="3892130" cy="738961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C23E5E0-C5F0-1C9B-0AC7-D4D268451AC6}"/>
                </a:ext>
              </a:extLst>
            </p:cNvPr>
            <p:cNvGrpSpPr/>
            <p:nvPr/>
          </p:nvGrpSpPr>
          <p:grpSpPr>
            <a:xfrm>
              <a:off x="5367501" y="5892159"/>
              <a:ext cx="3892130" cy="738961"/>
              <a:chOff x="4736333" y="539833"/>
              <a:chExt cx="3892130" cy="738961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6E6B9A29-5FF1-3617-3478-A3D76D0391AD}"/>
                  </a:ext>
                </a:extLst>
              </p:cNvPr>
              <p:cNvGrpSpPr/>
              <p:nvPr/>
            </p:nvGrpSpPr>
            <p:grpSpPr>
              <a:xfrm>
                <a:off x="4736333" y="539833"/>
                <a:ext cx="3892130" cy="687529"/>
                <a:chOff x="4991632" y="9684847"/>
                <a:chExt cx="4227594" cy="845589"/>
              </a:xfrm>
            </p:grpSpPr>
            <p:pic>
              <p:nvPicPr>
                <p:cNvPr id="36" name="Picture 35" descr="A graph of a number of people&#10;&#10;AI-generated content may be incorrect.">
                  <a:extLst>
                    <a:ext uri="{FF2B5EF4-FFF2-40B4-BE49-F238E27FC236}">
                      <a16:creationId xmlns:a16="http://schemas.microsoft.com/office/drawing/2014/main" id="{EE839A73-2D6A-98F0-CC5B-5A7D3EE675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084" t="94115" r="61780"/>
                <a:stretch/>
              </p:blipFill>
              <p:spPr>
                <a:xfrm>
                  <a:off x="4991632" y="9684847"/>
                  <a:ext cx="501661" cy="627728"/>
                </a:xfrm>
                <a:prstGeom prst="rect">
                  <a:avLst/>
                </a:prstGeom>
              </p:spPr>
            </p:pic>
            <p:pic>
              <p:nvPicPr>
                <p:cNvPr id="37" name="Picture 36" descr="A diagram of a number of numbers and flowers&#10;&#10;AI-generated content may be incorrect.">
                  <a:extLst>
                    <a:ext uri="{FF2B5EF4-FFF2-40B4-BE49-F238E27FC236}">
                      <a16:creationId xmlns:a16="http://schemas.microsoft.com/office/drawing/2014/main" id="{EF123A61-3C5B-ED5A-682E-E9CD5E71EC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248" t="80781" r="85968" b="15119"/>
                <a:stretch/>
              </p:blipFill>
              <p:spPr>
                <a:xfrm>
                  <a:off x="6572948" y="10233195"/>
                  <a:ext cx="416781" cy="297241"/>
                </a:xfrm>
                <a:prstGeom prst="rect">
                  <a:avLst/>
                </a:prstGeom>
              </p:spPr>
            </p:pic>
            <p:pic>
              <p:nvPicPr>
                <p:cNvPr id="38" name="Picture 37" descr="A diagram of a city&#10;&#10;AI-generated content may be incorrect.">
                  <a:extLst>
                    <a:ext uri="{FF2B5EF4-FFF2-40B4-BE49-F238E27FC236}">
                      <a16:creationId xmlns:a16="http://schemas.microsoft.com/office/drawing/2014/main" id="{F5B7C06F-AF28-D257-A8B2-39B68A0CBA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521" t="94553" r="47356" b="2322"/>
                <a:stretch/>
              </p:blipFill>
              <p:spPr>
                <a:xfrm>
                  <a:off x="6572948" y="9725491"/>
                  <a:ext cx="329491" cy="343924"/>
                </a:xfrm>
                <a:prstGeom prst="rect">
                  <a:avLst/>
                </a:prstGeom>
              </p:spPr>
            </p:pic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14CE352E-9D94-355B-761B-E125BAD5E6AE}"/>
                    </a:ext>
                  </a:extLst>
                </p:cNvPr>
                <p:cNvSpPr txBox="1"/>
                <p:nvPr/>
              </p:nvSpPr>
              <p:spPr>
                <a:xfrm>
                  <a:off x="5425519" y="9711972"/>
                  <a:ext cx="1312174" cy="3406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 of gene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D7E2829-29D3-EE00-9A0B-3D3C78826AFE}"/>
                    </a:ext>
                  </a:extLst>
                </p:cNvPr>
                <p:cNvSpPr txBox="1"/>
                <p:nvPr/>
              </p:nvSpPr>
              <p:spPr>
                <a:xfrm>
                  <a:off x="7403946" y="9727112"/>
                  <a:ext cx="1815280" cy="3406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 in isoform of gene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20078389-ADCD-2F94-6AAA-B348209BB926}"/>
                    </a:ext>
                  </a:extLst>
                </p:cNvPr>
                <p:cNvSpPr txBox="1"/>
                <p:nvPr/>
              </p:nvSpPr>
              <p:spPr>
                <a:xfrm>
                  <a:off x="7021324" y="10166168"/>
                  <a:ext cx="1556259" cy="3406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 coding region</a:t>
                  </a:r>
                </a:p>
              </p:txBody>
            </p:sp>
          </p:grpSp>
          <p:pic>
            <p:nvPicPr>
              <p:cNvPr id="34" name="Graphic 33" descr="Marker with solid fill">
                <a:extLst>
                  <a:ext uri="{FF2B5EF4-FFF2-40B4-BE49-F238E27FC236}">
                    <a16:creationId xmlns:a16="http://schemas.microsoft.com/office/drawing/2014/main" id="{6478F6B0-9D5E-AC5A-A8CD-F5E6BD04CC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4778433" y="884350"/>
                <a:ext cx="383709" cy="394444"/>
              </a:xfrm>
              <a:prstGeom prst="rect">
                <a:avLst/>
              </a:prstGeom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D415656-966B-8108-D6D6-6FE1FED556D1}"/>
                  </a:ext>
                </a:extLst>
              </p:cNvPr>
              <p:cNvSpPr txBox="1"/>
              <p:nvPr/>
            </p:nvSpPr>
            <p:spPr>
              <a:xfrm>
                <a:off x="4983690" y="973160"/>
                <a:ext cx="1054646" cy="261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P position</a:t>
                </a:r>
              </a:p>
            </p:txBody>
          </p:sp>
        </p:grpSp>
        <p:pic>
          <p:nvPicPr>
            <p:cNvPr id="42" name="Picture 41" descr="A diagram of a graph&#10;&#10;AI-generated content may be incorrect.">
              <a:extLst>
                <a:ext uri="{FF2B5EF4-FFF2-40B4-BE49-F238E27FC236}">
                  <a16:creationId xmlns:a16="http://schemas.microsoft.com/office/drawing/2014/main" id="{B890C42C-1D00-AA32-CA1E-09B1BCCC8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43" t="94098" r="48327" b="2624"/>
            <a:stretch/>
          </p:blipFill>
          <p:spPr>
            <a:xfrm>
              <a:off x="7111310" y="5945567"/>
              <a:ext cx="249651" cy="252206"/>
            </a:xfrm>
            <a:prstGeom prst="rect">
              <a:avLst/>
            </a:prstGeom>
          </p:spPr>
        </p:pic>
        <p:pic>
          <p:nvPicPr>
            <p:cNvPr id="43" name="Picture 42" descr="A diagram of a graph&#10;&#10;AI-generated content may be incorrect.">
              <a:extLst>
                <a:ext uri="{FF2B5EF4-FFF2-40B4-BE49-F238E27FC236}">
                  <a16:creationId xmlns:a16="http://schemas.microsoft.com/office/drawing/2014/main" id="{1B47A2B2-5587-F34E-46D2-1C3CF23FC91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246" t="94038" r="29599" b="2742"/>
            <a:stretch/>
          </p:blipFill>
          <p:spPr>
            <a:xfrm>
              <a:off x="7374469" y="5930306"/>
              <a:ext cx="238102" cy="25145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60906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302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wais Riaz</dc:creator>
  <cp:lastModifiedBy>Awais Riaz</cp:lastModifiedBy>
  <cp:revision>8</cp:revision>
  <dcterms:created xsi:type="dcterms:W3CDTF">2025-04-09T02:44:10Z</dcterms:created>
  <dcterms:modified xsi:type="dcterms:W3CDTF">2026-01-11T16:43:59Z</dcterms:modified>
</cp:coreProperties>
</file>